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6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9B122F-F77A-444A-B520-4119BC3307A8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3B40A5-0611-402F-A8A3-ABBF1AEC1884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0170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FB1BA0-936A-DF02-ED08-50DAF1F3A1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E61DEC7-DE22-0423-3E27-4466F441FA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B2C431-303A-D951-5673-4E8A2A77E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64C896-8502-3F36-C7C1-FC643B5A8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DA1253-708A-4ED2-CE0D-64592CCA62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3974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4D61EF-01CB-E40E-4FB8-32D3417AD5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FC2575-CFDE-187E-444F-76CB15E05D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BD2737-ED31-434C-6256-21C5F36B85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D34EA6C-F631-482C-8347-0C4D3E4F54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CE2A1A-B8FE-FB31-5953-64940424C4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0356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C43B43F-DCD5-80F5-098D-2AD389959E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9260F0-E4F8-6B04-BFEC-32565F1728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4C6089-8041-E51A-AC66-D603E0617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25958D-35BA-410C-496D-33A52094AA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8F7A2D-3432-2E4A-CF0A-7B1A5399F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108420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2002E1-F760-9DC3-FBB0-2078A60963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7F2118-AD94-4BF6-2715-2B5D163693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C7655C-567C-D7EC-086E-351DEE86C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69A1E9-BF2F-BF73-1B59-5DD440A7BB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E55E37-AE81-678A-D750-08BF00EC1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8341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E8C769-18E8-62B9-A159-6570E8A78C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E66848-19EE-C14A-AB97-1294806CB2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3671CB-16C5-7ABF-C5DD-CD9616574F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94E9F3-5405-2B15-5BC4-245CAB15A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929467-33CC-3224-A00B-33A0BCD30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7928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2877E1-B9F2-9FA1-485D-BFAD04C28A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9A4B8F-0896-FB51-AC0E-8B230764CE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FA6C18F-1DED-4CDF-8409-88C737AE6C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03DC38-2328-012C-A046-AC2C775A71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0BA32E-4C84-B011-A24B-026F70132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03EC52-705C-91CE-4391-C5D471C31B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3488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E15206-4239-DBAB-F5CD-9FE1A77B03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0B1A4B-C7E9-30E3-F1F9-7190D20CE0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EA6A51-D19C-2528-07EE-F21394A3AC8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551918B-F1A6-FAB1-0C64-EC5CF9DFAD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7E2159-E434-D6E5-7BAB-3029C91847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58875EC-6582-5693-F31A-04E3D77D8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A4CDC8F-B3D4-901F-393E-C1D7F5F7B6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E68615-D49E-20FE-A917-8FB8543521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5614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E86584-CE89-2BE6-2FE8-4A2B32F3F4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1E29BE8-A7C3-1801-D71F-71AA04DDC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5ADA298-D4A5-1A25-57F1-D4DA76F22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60F087E-FCAB-34C4-795C-D1ED88E0BD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0908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8E4BDE2-2B73-0EEE-4885-AB856804B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350EF5B-4421-B9A8-3954-9500615ACB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EB05F5B-83F8-8E3E-4AA8-20EC1D2EE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6204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50ACA7-4D9D-3129-ABE1-A83A69A8B4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E01D95-DA54-5666-5F6B-FD4C3439B0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ECDC43-3F26-D95E-3BF8-E9107EE6C6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378AEF-FAAB-5F8C-A401-2EF4E41822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AFF32B-9C64-8049-5989-2678315F8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CAF706-2F13-B1FC-B7C7-5A535361B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40774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03313D-A655-A393-8D90-F1E021DF3F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E99063B-D626-CEDB-291E-F2B02206BD0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427751-3844-9BBA-4566-39F16D060E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7416AA6-9F47-BE2E-E868-48F112A43C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B18507-B2E6-4780-4507-164BA30AE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9EA6BC-FDBA-EC1F-232A-DBCDE8387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9806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7CBF482-DEE0-E62B-4637-D8CA4364C8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fr-FR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34F2807-0383-6AF7-D086-B342381ECA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8DE6EE-3E6B-E29C-9EA5-A4911B5DF86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AE6AA2-F10F-4407-85E6-826C8739097B}" type="datetimeFigureOut">
              <a:rPr lang="fr-FR" smtClean="0"/>
              <a:t>07/07/2025</a:t>
            </a:fld>
            <a:endParaRPr lang="fr-FR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012443-6AB0-6F50-F681-E61A77CB358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0A0C8E-71B4-3163-A0A4-7FB27D9A7F2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73B530C-46B1-4131-90FD-AE33F734DDED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72721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50E38B6-3DC1-8A16-8B5C-51294D4259A7}"/>
              </a:ext>
            </a:extLst>
          </p:cNvPr>
          <p:cNvSpPr txBox="1"/>
          <p:nvPr/>
        </p:nvSpPr>
        <p:spPr>
          <a:xfrm>
            <a:off x="463588" y="5657671"/>
            <a:ext cx="1126482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400" b="1" dirty="0"/>
              <a:t>Supplementary Figure S1. </a:t>
            </a:r>
            <a:r>
              <a:rPr lang="en-GB" sz="1400" dirty="0"/>
              <a:t>Alpha diversity at baseline, three months, and twelve months, irrespective of treatment outcome. No significant differences were observed between baseline and three months (P &gt; 0.05), baseline and twelve months (P &gt; 0.05), or between three months and twelve months (P &gt; 0.05) (Mann-Whitney test).</a:t>
            </a:r>
            <a:endParaRPr lang="fr-FR" sz="1400" dirty="0"/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6C9E3167-8799-453C-EB8B-45022E25CCD6}"/>
              </a:ext>
            </a:extLst>
          </p:cNvPr>
          <p:cNvGrpSpPr/>
          <p:nvPr/>
        </p:nvGrpSpPr>
        <p:grpSpPr>
          <a:xfrm>
            <a:off x="2922104" y="461665"/>
            <a:ext cx="5458541" cy="4698530"/>
            <a:chOff x="2931832" y="132498"/>
            <a:chExt cx="5458541" cy="4698530"/>
          </a:xfrm>
        </p:grpSpPr>
        <p:pic>
          <p:nvPicPr>
            <p:cNvPr id="5" name="Picture 4" descr="A diagram of a number of squares&#10;&#10;AI-generated content may be incorrect.">
              <a:extLst>
                <a:ext uri="{FF2B5EF4-FFF2-40B4-BE49-F238E27FC236}">
                  <a16:creationId xmlns:a16="http://schemas.microsoft.com/office/drawing/2014/main" id="{292077C0-E1E5-B95C-7C5C-0ABE86A5DE1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85"/>
            <a:stretch/>
          </p:blipFill>
          <p:spPr>
            <a:xfrm>
              <a:off x="2931832" y="886119"/>
              <a:ext cx="5458541" cy="3944909"/>
            </a:xfrm>
            <a:prstGeom prst="rect">
              <a:avLst/>
            </a:prstGeom>
          </p:spPr>
        </p:pic>
        <p:sp>
          <p:nvSpPr>
            <p:cNvPr id="2" name="Left Bracket 1">
              <a:extLst>
                <a:ext uri="{FF2B5EF4-FFF2-40B4-BE49-F238E27FC236}">
                  <a16:creationId xmlns:a16="http://schemas.microsoft.com/office/drawing/2014/main" id="{4996B120-C619-615A-DBCD-08F74E549CA2}"/>
                </a:ext>
              </a:extLst>
            </p:cNvPr>
            <p:cNvSpPr/>
            <p:nvPr/>
          </p:nvSpPr>
          <p:spPr>
            <a:xfrm rot="5400000">
              <a:off x="4958319" y="-54457"/>
              <a:ext cx="57776" cy="1622267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FD60D21E-D7E0-4153-F909-D98A2C56E9C5}"/>
                </a:ext>
              </a:extLst>
            </p:cNvPr>
            <p:cNvSpPr txBox="1"/>
            <p:nvPr/>
          </p:nvSpPr>
          <p:spPr>
            <a:xfrm>
              <a:off x="4736798" y="385455"/>
              <a:ext cx="4667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b="1" dirty="0"/>
                <a:t>ns</a:t>
              </a:r>
              <a:endParaRPr lang="fr-FR" sz="2000" b="1" dirty="0"/>
            </a:p>
          </p:txBody>
        </p:sp>
        <p:sp>
          <p:nvSpPr>
            <p:cNvPr id="6" name="Left Bracket 5">
              <a:extLst>
                <a:ext uri="{FF2B5EF4-FFF2-40B4-BE49-F238E27FC236}">
                  <a16:creationId xmlns:a16="http://schemas.microsoft.com/office/drawing/2014/main" id="{798BBD43-45CB-4709-AA18-84EDEFF916F5}"/>
                </a:ext>
              </a:extLst>
            </p:cNvPr>
            <p:cNvSpPr/>
            <p:nvPr/>
          </p:nvSpPr>
          <p:spPr>
            <a:xfrm rot="5400000">
              <a:off x="6568913" y="87983"/>
              <a:ext cx="51844" cy="1591557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7324A23-DCDF-E745-E3FA-EC4081054CEC}"/>
                </a:ext>
              </a:extLst>
            </p:cNvPr>
            <p:cNvSpPr txBox="1"/>
            <p:nvPr/>
          </p:nvSpPr>
          <p:spPr>
            <a:xfrm>
              <a:off x="6359781" y="509574"/>
              <a:ext cx="4667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b="1" dirty="0"/>
                <a:t>ns</a:t>
              </a:r>
              <a:endParaRPr lang="fr-FR" sz="2000" b="1" dirty="0"/>
            </a:p>
          </p:txBody>
        </p:sp>
        <p:sp>
          <p:nvSpPr>
            <p:cNvPr id="8" name="Left Bracket 7">
              <a:extLst>
                <a:ext uri="{FF2B5EF4-FFF2-40B4-BE49-F238E27FC236}">
                  <a16:creationId xmlns:a16="http://schemas.microsoft.com/office/drawing/2014/main" id="{F34148AB-E9C6-069E-3F5E-10E4C8AB45FD}"/>
                </a:ext>
              </a:extLst>
            </p:cNvPr>
            <p:cNvSpPr/>
            <p:nvPr/>
          </p:nvSpPr>
          <p:spPr>
            <a:xfrm rot="5400000">
              <a:off x="5745949" y="-1125223"/>
              <a:ext cx="57777" cy="3231554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7139F11D-3863-BA88-5AE2-03F662965DC7}"/>
                </a:ext>
              </a:extLst>
            </p:cNvPr>
            <p:cNvSpPr txBox="1"/>
            <p:nvPr/>
          </p:nvSpPr>
          <p:spPr>
            <a:xfrm>
              <a:off x="5539647" y="132498"/>
              <a:ext cx="4667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b="1" dirty="0"/>
                <a:t>ns</a:t>
              </a:r>
              <a:endParaRPr lang="fr-FR" sz="20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5130792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5</TotalTime>
  <Words>64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>IAR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rik Gheit</dc:creator>
  <cp:lastModifiedBy>Arun Sharma</cp:lastModifiedBy>
  <cp:revision>23</cp:revision>
  <dcterms:created xsi:type="dcterms:W3CDTF">2025-02-21T17:56:07Z</dcterms:created>
  <dcterms:modified xsi:type="dcterms:W3CDTF">2025-07-07T08:08:54Z</dcterms:modified>
</cp:coreProperties>
</file>